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8A1A90-17A1-4E28-DDC1-883117E5E503}" name="Giovanni Barbara" initials="GB" userId="S::giovanni.barbara@unibo.it::7e91a206-5663-4690-892a-3c3426af7a7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81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dke\Dropbox\University\POST-DOC\Bologna%20University\GI%20COVID19\1st%20study%20-%20DGBI%20vs.%20NON-DGBI%20and%20symptoms%20fluctations\Results\Figures%202%20for%20severity-%204%20time%20poin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e-I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2'!$A$26:$A$32</c:f>
              <c:strCache>
                <c:ptCount val="7"/>
                <c:pt idx="0">
                  <c:v>Functional dyspepsia</c:v>
                </c:pt>
                <c:pt idx="1">
                  <c:v>IBS</c:v>
                </c:pt>
                <c:pt idx="2">
                  <c:v>Postprandial distress syndrome</c:v>
                </c:pt>
                <c:pt idx="3">
                  <c:v>Epigastric pain syndrome</c:v>
                </c:pt>
                <c:pt idx="4">
                  <c:v>Chronic nausea vomiting syndrome</c:v>
                </c:pt>
                <c:pt idx="5">
                  <c:v>Cyclic vomitig syndrome</c:v>
                </c:pt>
                <c:pt idx="6">
                  <c:v>Functional diarrhea</c:v>
                </c:pt>
              </c:strCache>
            </c:strRef>
          </c:cat>
          <c:val>
            <c:numRef>
              <c:f>'2'!$B$26:$B$32</c:f>
            </c:numRef>
          </c:val>
          <c:extLst>
            <c:ext xmlns:c16="http://schemas.microsoft.com/office/drawing/2014/chart" uri="{C3380CC4-5D6E-409C-BE32-E72D297353CC}">
              <c16:uniqueId val="{00000000-A7F0-4248-8631-3DBD6150DB7A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2'!$A$26:$A$32</c:f>
              <c:strCache>
                <c:ptCount val="7"/>
                <c:pt idx="0">
                  <c:v>Functional dyspepsia</c:v>
                </c:pt>
                <c:pt idx="1">
                  <c:v>IBS</c:v>
                </c:pt>
                <c:pt idx="2">
                  <c:v>Postprandial distress syndrome</c:v>
                </c:pt>
                <c:pt idx="3">
                  <c:v>Epigastric pain syndrome</c:v>
                </c:pt>
                <c:pt idx="4">
                  <c:v>Chronic nausea vomiting syndrome</c:v>
                </c:pt>
                <c:pt idx="5">
                  <c:v>Cyclic vomitig syndrome</c:v>
                </c:pt>
                <c:pt idx="6">
                  <c:v>Functional diarrhea</c:v>
                </c:pt>
              </c:strCache>
            </c:strRef>
          </c:cat>
          <c:val>
            <c:numRef>
              <c:f>'2'!$C$26:$C$32</c:f>
            </c:numRef>
          </c:val>
          <c:extLst>
            <c:ext xmlns:c16="http://schemas.microsoft.com/office/drawing/2014/chart" uri="{C3380CC4-5D6E-409C-BE32-E72D297353CC}">
              <c16:uniqueId val="{00000001-A7F0-4248-8631-3DBD6150DB7A}"/>
            </c:ext>
          </c:extLst>
        </c:ser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2'!$A$26:$A$32</c:f>
              <c:strCache>
                <c:ptCount val="7"/>
                <c:pt idx="0">
                  <c:v>Functional dyspepsia</c:v>
                </c:pt>
                <c:pt idx="1">
                  <c:v>IBS</c:v>
                </c:pt>
                <c:pt idx="2">
                  <c:v>Postprandial distress syndrome</c:v>
                </c:pt>
                <c:pt idx="3">
                  <c:v>Epigastric pain syndrome</c:v>
                </c:pt>
                <c:pt idx="4">
                  <c:v>Chronic nausea vomiting syndrome</c:v>
                </c:pt>
                <c:pt idx="5">
                  <c:v>Cyclic vomitig syndrome</c:v>
                </c:pt>
                <c:pt idx="6">
                  <c:v>Functional diarrhea</c:v>
                </c:pt>
              </c:strCache>
            </c:strRef>
          </c:cat>
          <c:val>
            <c:numRef>
              <c:f>'2'!$D$26:$D$32</c:f>
            </c:numRef>
          </c:val>
          <c:extLst>
            <c:ext xmlns:c16="http://schemas.microsoft.com/office/drawing/2014/chart" uri="{C3380CC4-5D6E-409C-BE32-E72D297353CC}">
              <c16:uniqueId val="{00000002-A7F0-4248-8631-3DBD6150DB7A}"/>
            </c:ext>
          </c:extLst>
        </c:ser>
        <c:ser>
          <c:idx val="3"/>
          <c:order val="3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he-IL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2'!$A$26:$A$32</c:f>
              <c:strCache>
                <c:ptCount val="7"/>
                <c:pt idx="0">
                  <c:v>Functional dyspepsia</c:v>
                </c:pt>
                <c:pt idx="1">
                  <c:v>IBS</c:v>
                </c:pt>
                <c:pt idx="2">
                  <c:v>Postprandial distress syndrome</c:v>
                </c:pt>
                <c:pt idx="3">
                  <c:v>Epigastric pain syndrome</c:v>
                </c:pt>
                <c:pt idx="4">
                  <c:v>Chronic nausea vomiting syndrome</c:v>
                </c:pt>
                <c:pt idx="5">
                  <c:v>Cyclic vomitig syndrome</c:v>
                </c:pt>
                <c:pt idx="6">
                  <c:v>Functional diarrhea</c:v>
                </c:pt>
              </c:strCache>
            </c:strRef>
          </c:cat>
          <c:val>
            <c:numRef>
              <c:f>'2'!$E$26:$E$32</c:f>
              <c:numCache>
                <c:formatCode>0.0%</c:formatCode>
                <c:ptCount val="7"/>
                <c:pt idx="0">
                  <c:v>0.62962962962962965</c:v>
                </c:pt>
                <c:pt idx="1">
                  <c:v>0.37037037037037035</c:v>
                </c:pt>
                <c:pt idx="2">
                  <c:v>0.37037037037037035</c:v>
                </c:pt>
                <c:pt idx="3">
                  <c:v>0.29629629629629628</c:v>
                </c:pt>
                <c:pt idx="4">
                  <c:v>0.1111111111111111</c:v>
                </c:pt>
                <c:pt idx="5">
                  <c:v>3.7037037037037035E-2</c:v>
                </c:pt>
                <c:pt idx="6">
                  <c:v>3.70370370370370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F0-4248-8631-3DBD6150DB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5090623"/>
        <c:axId val="515097823"/>
      </c:barChart>
      <c:catAx>
        <c:axId val="5150906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515097823"/>
        <c:crosses val="autoZero"/>
        <c:auto val="1"/>
        <c:lblAlgn val="ctr"/>
        <c:lblOffset val="100"/>
        <c:noMultiLvlLbl val="0"/>
      </c:catAx>
      <c:valAx>
        <c:axId val="51509782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% Of patients with post-COVID-19 DGBI</a:t>
                </a:r>
                <a:endParaRPr lang="he-IL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5150906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6F9470-DDD9-8CE3-610E-03E1BE2580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C596BD5-ACD5-9C0A-645A-8F6CDF4913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596231-1250-68D7-31F4-C8577EA24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4B7781F-0453-F304-BE35-126485CAF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F2078A-EBC1-1660-E33E-83EDD6D07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8319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9158D33-9E39-8CE2-E6A7-49A205E75E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EADB0DB-7B35-50A5-75ED-796068B41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1AA77C4-CAA5-35CA-C7E2-3FE6213BB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DA6B0A-5F61-1102-C540-A0CA87131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7A86968-D535-B2CF-CA20-F21F1D21D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9274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19E656F-428A-D14B-BA88-AC35E96847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1DDC752-7F68-1194-0BDC-B4C83D54E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A6F4C2B-4350-EAD0-60D3-C59EB0DCB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85FDDB-FE36-C213-40B4-777E5FBDD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9943FB-31C4-E252-AC05-22D5B250C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8682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9DBFFF-5016-8A6E-3DAC-25D470F4F3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40DC39F-FC95-E79E-2733-CA01B0D903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176F1BA-EE1D-3A89-1FDD-15286470C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98AAC0F-0F83-9A0D-63C0-F8E8CBDA4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7084979-C34C-B7D5-EB10-9C2333D70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8528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E8B170-E597-ADA4-812F-62AF43A5FF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DA3F79C-7120-F8D2-E1D0-2CA38A5374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B612D8-9FB4-C2B9-3E12-250AA07A4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B4F158F-8EF9-AA59-36BF-256ED5A9C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73BD31E-2100-35E5-6535-B09B5BA4C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5458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3465BF-6780-88B2-F805-FD8A303DC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1DCC5F-D7D8-539A-3899-8D97BC6C1F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BA80BB5-26DD-B57A-E27B-9DE2541253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72109B2-9F23-A7DB-C0C8-DD0DBCEE0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DC25464-378E-1871-18AD-4EC82D00F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5A4EA9A-561D-9280-10C7-00DD2CD12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94392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38F9536-25B0-DAE8-DA2C-04418583D2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922928D-0131-218D-EF1D-F4B58D0E04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E38B071-EDB6-313E-39A9-34BA35981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7BEC0C58-D19D-9EB7-3F9D-E6E919118D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64CA529-FC69-E6C0-E40D-3ED24E56DA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4DA516B-1BBD-D122-A4F1-92FD45DA0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713FF55-04CD-D12B-E529-BFE64B602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657A63D-9503-02E3-AE78-888DF56EA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6357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6760231-2F71-C912-3C3F-42ACB5067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00EFA55-FD95-352C-F193-14CCC52A4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55F14AA-B4F7-63C0-CEE1-FDA4ADE90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A9C2986-B3E4-D902-3B25-24A10B920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3778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2B42389-D8A2-570D-33A6-8F9D643CE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8D2C0050-19B4-52BB-8417-D67A28647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701F07C-B5DA-9AD0-1C4F-A5C04200A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6525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24DC10D-3EA3-4F5B-8013-52BA64CC0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FFA76D0-4CE5-D149-4E78-6FB345BAD7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FF2B4E9-26FB-7157-415F-B2ADEB3A2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5E37540-BBBA-3EE2-94FE-62FD981AE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5C5457-2D71-EF02-0545-91242DD8F2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39ED5E1-DA89-2A9F-6289-AB998BE22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4744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718AC9-1DB9-59CE-6FF0-7D918E088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C547DBF-7D4D-3841-1D41-476E6EC209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41F964E-7D66-53B3-89E5-FC386A6039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717AEB5-7514-FDE0-1704-C701AB7031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DE07C7B-A545-294D-9A01-090D12CFF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7AE6275-9F9F-0FC5-B39B-C4E115691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6246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210967A-923E-FF82-C6FD-6A15377C4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4C2DB44-65F6-685E-EFF2-24E5CE647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FEE2AAC-FF34-0B63-6567-31DA84658E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CB6EE-26DF-DC49-ADE7-CA69B398E24C}" type="datetimeFigureOut">
              <a:rPr lang="it-IT" smtClean="0"/>
              <a:t>10/02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791EF7-60BC-4750-BD69-00B38912B8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F502583-0B4E-1453-0693-7B20D7FB86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4CB9E-15F5-B443-B469-AC0E6453F52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763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תרשים 2">
            <a:extLst>
              <a:ext uri="{FF2B5EF4-FFF2-40B4-BE49-F238E27FC236}">
                <a16:creationId xmlns:a16="http://schemas.microsoft.com/office/drawing/2014/main" id="{DAA9672D-D84D-E52F-D0D6-B9200D3EE1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7713105"/>
              </p:ext>
            </p:extLst>
          </p:nvPr>
        </p:nvGraphicFramePr>
        <p:xfrm>
          <a:off x="886967" y="644893"/>
          <a:ext cx="10701849" cy="5536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תיבת טקסט 3">
            <a:extLst>
              <a:ext uri="{FF2B5EF4-FFF2-40B4-BE49-F238E27FC236}">
                <a16:creationId xmlns:a16="http://schemas.microsoft.com/office/drawing/2014/main" id="{817BB323-17A3-EBEF-EAC6-9212F5D756D0}"/>
              </a:ext>
            </a:extLst>
          </p:cNvPr>
          <p:cNvSpPr txBox="1"/>
          <p:nvPr/>
        </p:nvSpPr>
        <p:spPr>
          <a:xfrm>
            <a:off x="1517904" y="6285543"/>
            <a:ext cx="10378440" cy="3298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.1 </a:t>
            </a:r>
            <a:r>
              <a:rPr lang="x-none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GBIs distributions among post-COVID-19 DGBIs patients. Same patients could have more than one DGBI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1193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26</Words>
  <Application>Microsoft Office PowerPoint</Application>
  <PresentationFormat>מסך רחב</PresentationFormat>
  <Paragraphs>2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4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igi Colecchia - luigi.colecchia@studio.unibo.it</dc:creator>
  <cp:lastModifiedBy>קרן הוד</cp:lastModifiedBy>
  <cp:revision>30</cp:revision>
  <dcterms:created xsi:type="dcterms:W3CDTF">2024-08-03T17:28:14Z</dcterms:created>
  <dcterms:modified xsi:type="dcterms:W3CDTF">2025-02-10T19:59:43Z</dcterms:modified>
</cp:coreProperties>
</file>